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3229C8-A51F-47A4-8DBD-4F19990E4E8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023E07B-CF38-48EE-8136-3EE4CF1C06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90D8C5-F73D-4638-81D0-3D70FBC0B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16E62-AB29-47FC-A398-7F060CC1FF3A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448110-6AFA-4F78-A99E-C56F8F9E62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7306F4-6865-43F9-869A-3E27313645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C0712-AD80-4ED1-9DA0-E6B1456B25E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005167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F4107E-E9DB-44E0-88F1-F9EE55F58C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5F23186-F5FF-4B6C-A735-3157814E36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643885-1E06-40AD-89A7-CC434F8443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16E62-AB29-47FC-A398-7F060CC1FF3A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B94134-A2B4-4805-AB06-420CD10B7D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A7A016-619E-44EF-91F9-652151EE0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C0712-AD80-4ED1-9DA0-E6B1456B25E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4114480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D0A4BD5-D7DF-428C-B010-97AEA6BD23D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ABB7F0-8A6B-473E-A38B-DD3CCC50ED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C2D086-AFA0-4DE2-8442-B64D585FEB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16E62-AB29-47FC-A398-7F060CC1FF3A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681E56-12A2-45D9-8B07-8BB3096514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368F6C-D98B-4EA4-A7FE-11D4027005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C0712-AD80-4ED1-9DA0-E6B1456B25E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266438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F16741-7583-4733-9B4D-DF3581CF62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15A39D-954F-4E4F-8391-D0C7AADEC45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7A90DB-ABAD-4594-9EDB-6DDCEEA610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16E62-AB29-47FC-A398-7F060CC1FF3A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10865F-4EC2-417E-82EE-E667E5CCFE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94E471-3F6F-4967-AE17-5F57DD8918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C0712-AD80-4ED1-9DA0-E6B1456B25E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6201087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921BBC-9929-4FE8-BBDC-6EB1553577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0AE165-BBEF-4A02-873B-696CF4DF62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84B06E-4E8E-4E6A-9355-0432FF78E6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16E62-AB29-47FC-A398-7F060CC1FF3A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F9ACDA-2E20-43D1-B4BB-9D9BEAFDC6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22CA2B-3033-45CA-95A6-49FC36B927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C0712-AD80-4ED1-9DA0-E6B1456B25E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22144788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C6EEE4-F643-4E2C-A895-F1AFDDE0CB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852ED5-000E-40F5-8434-EA7345FCD5B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FD26C63-C16C-4BD7-9779-D7CD9917E5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2C7ADA-4DEC-4C1A-8ABB-25C58AE3A5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16E62-AB29-47FC-A398-7F060CC1FF3A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F864EE-2B2A-4EA7-9F53-0B522CD34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9DE39B-7193-46E4-BCD4-B9A94BA412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C0712-AD80-4ED1-9DA0-E6B1456B25E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285392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7434A5-DCE7-4B2F-A43D-A5AEF618C2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52B79B-FB40-4C37-AB64-27E91477C1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01A9BA-90AB-4B9F-B4D7-2D4009554D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0FB7C91-928F-4543-8793-E27CD233ED9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79D2BC4-C6F2-4A9E-A649-56BB207451D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8E09A3C-5C4C-4D7C-AC2C-B39109005B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16E62-AB29-47FC-A398-7F060CC1FF3A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B5A4056-DD0D-44F1-8A7E-7A8910439D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1CDDA28-FAC0-4DE4-9971-FC6C6B4841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C0712-AD80-4ED1-9DA0-E6B1456B25E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135697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F7C217-EC75-4991-94B9-6CBCAE0770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2433B51-537C-4911-885C-39E10B1EC5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16E62-AB29-47FC-A398-7F060CC1FF3A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88D11CD-0A52-454A-8B6B-31A9C23DE5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E7D4DDC-1A87-4C3D-B986-5BADC0852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C0712-AD80-4ED1-9DA0-E6B1456B25E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29774255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871CDA9-F744-4C43-B362-E724F7333E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16E62-AB29-47FC-A398-7F060CC1FF3A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62ED7F7-CCB7-4B8D-906E-8964FA14FC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5472FD2-E2D8-459E-A516-E68D83FC8F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C0712-AD80-4ED1-9DA0-E6B1456B25E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088234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8730EC-37C3-478D-9BAA-478BA7E2F2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A0910D-A536-44D8-9C16-F1F1E566F9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A837D49-3F47-4D9D-B17A-85189153A5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6FBD1E-7E91-4FBE-A64B-A7C49190F4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16E62-AB29-47FC-A398-7F060CC1FF3A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C0E7D5-3008-4D01-B634-06B633D67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CDE1FF-F7AB-4137-B337-B83D22C079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C0712-AD80-4ED1-9DA0-E6B1456B25E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5158415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EFA3F1-4001-43A0-B77E-A166F10A27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69D76F7-AB46-4D0B-9CD5-D8DBD92982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D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ED0ABE-5400-402E-B272-CD4EF74B4A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12FF9B-8A9B-4DD3-B177-2C0D770844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16E62-AB29-47FC-A398-7F060CC1FF3A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BF912C-B2D0-442C-B81C-8A656044CB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CA3195-CC1C-4B9D-B90F-B24A6F63AD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C0712-AD80-4ED1-9DA0-E6B1456B25E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366889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9A0741D-F7A1-45C1-9BD1-CA643B49ED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0E62C3-7DF3-41F3-ACFC-F1409FBA85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9AEEE1-273C-48F6-9B0E-CD465CC0D4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E16E62-AB29-47FC-A398-7F060CC1FF3A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2FA3F9-5791-45A9-A495-1D10D5F0D6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CEBB3A-C312-418B-98FF-9C0DE90BDE0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FC0712-AD80-4ED1-9DA0-E6B1456B25EC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25592323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23C3E0D-FF86-47B2-84D5-1C8E945827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73417" y="602570"/>
            <a:ext cx="7297177" cy="539555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A3079F5-B8B8-A408-1C1E-CEA000E8494B}"/>
              </a:ext>
            </a:extLst>
          </p:cNvPr>
          <p:cNvSpPr txBox="1"/>
          <p:nvPr/>
        </p:nvSpPr>
        <p:spPr>
          <a:xfrm>
            <a:off x="3875714" y="1602297"/>
            <a:ext cx="54360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able 4a. Reference range of WBC, RBC, HGB, HCT, MCV, MCH for healthy babies aged 1 month</a:t>
            </a:r>
          </a:p>
        </p:txBody>
      </p:sp>
    </p:spTree>
    <p:extLst>
      <p:ext uri="{BB962C8B-B14F-4D97-AF65-F5344CB8AC3E}">
        <p14:creationId xmlns:p14="http://schemas.microsoft.com/office/powerpoint/2010/main" val="37592471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D14AEBF-C298-4836-B105-676E54785E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2809" y="964735"/>
            <a:ext cx="8437917" cy="483205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4136778-8EF0-DC04-56C3-92FA8616205F}"/>
              </a:ext>
            </a:extLst>
          </p:cNvPr>
          <p:cNvSpPr txBox="1"/>
          <p:nvPr/>
        </p:nvSpPr>
        <p:spPr>
          <a:xfrm>
            <a:off x="3318901" y="1937857"/>
            <a:ext cx="53857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able 4b. Reference range of MCHC, PLT, RDW SD, RDW CV, PDW, MPV for healthy babies aged 1 month</a:t>
            </a:r>
          </a:p>
        </p:txBody>
      </p:sp>
    </p:spTree>
    <p:extLst>
      <p:ext uri="{BB962C8B-B14F-4D97-AF65-F5344CB8AC3E}">
        <p14:creationId xmlns:p14="http://schemas.microsoft.com/office/powerpoint/2010/main" val="36721057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2D1F1E6-C229-4C70-B504-4F7812561F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88859" y="820324"/>
            <a:ext cx="7901987" cy="514424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ED29C2A-5028-713A-7BCD-B79E21CACF69}"/>
              </a:ext>
            </a:extLst>
          </p:cNvPr>
          <p:cNvSpPr txBox="1"/>
          <p:nvPr/>
        </p:nvSpPr>
        <p:spPr>
          <a:xfrm>
            <a:off x="3439486" y="1845578"/>
            <a:ext cx="67363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D" dirty="0"/>
              <a:t>Table 4c. Reference range of PCT, neutrophil, lymphocyte, monocyte, eosinophil, eosinophil </a:t>
            </a:r>
            <a:r>
              <a:rPr lang="en-ID" dirty="0" err="1"/>
              <a:t>absolut</a:t>
            </a:r>
            <a:r>
              <a:rPr lang="en-ID" dirty="0"/>
              <a:t> for healthy babies aged 1 month</a:t>
            </a:r>
          </a:p>
        </p:txBody>
      </p:sp>
    </p:spTree>
    <p:extLst>
      <p:ext uri="{BB962C8B-B14F-4D97-AF65-F5344CB8AC3E}">
        <p14:creationId xmlns:p14="http://schemas.microsoft.com/office/powerpoint/2010/main" val="21170566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E17DFE4-F04D-4C81-929E-1ED425EA57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1840" y="713064"/>
            <a:ext cx="10427901" cy="541089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38315B6-F1AB-AB00-878C-D5A5E8EA131D}"/>
              </a:ext>
            </a:extLst>
          </p:cNvPr>
          <p:cNvSpPr txBox="1"/>
          <p:nvPr/>
        </p:nvSpPr>
        <p:spPr>
          <a:xfrm>
            <a:off x="2432807" y="1786855"/>
            <a:ext cx="861549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D" dirty="0"/>
              <a:t>Table 4d. Reference range of basophil, basophil </a:t>
            </a:r>
            <a:r>
              <a:rPr lang="en-ID" dirty="0" err="1"/>
              <a:t>absolut</a:t>
            </a:r>
            <a:r>
              <a:rPr lang="en-ID" dirty="0"/>
              <a:t>, IPF, IG, RPI, IRF, reticulocyte </a:t>
            </a:r>
            <a:r>
              <a:rPr lang="en-ID" dirty="0" err="1"/>
              <a:t>hemoglobin</a:t>
            </a:r>
            <a:r>
              <a:rPr lang="en-ID" dirty="0"/>
              <a:t>, reticulocyte </a:t>
            </a:r>
            <a:r>
              <a:rPr lang="en-ID" dirty="0" err="1"/>
              <a:t>hemoglobin</a:t>
            </a:r>
            <a:r>
              <a:rPr lang="en-ID" dirty="0"/>
              <a:t> %, reticulocyte </a:t>
            </a:r>
            <a:r>
              <a:rPr lang="en-ID" dirty="0" err="1"/>
              <a:t>hemoglobin</a:t>
            </a:r>
            <a:r>
              <a:rPr lang="en-ID" dirty="0"/>
              <a:t> in million for healthy babies aged 1 month</a:t>
            </a:r>
          </a:p>
        </p:txBody>
      </p:sp>
    </p:spTree>
    <p:extLst>
      <p:ext uri="{BB962C8B-B14F-4D97-AF65-F5344CB8AC3E}">
        <p14:creationId xmlns:p14="http://schemas.microsoft.com/office/powerpoint/2010/main" val="34111518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107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lindungan ringoringo</dc:creator>
  <cp:lastModifiedBy>parlindungan ringoringo</cp:lastModifiedBy>
  <cp:revision>2</cp:revision>
  <dcterms:created xsi:type="dcterms:W3CDTF">2022-02-16T21:47:40Z</dcterms:created>
  <dcterms:modified xsi:type="dcterms:W3CDTF">2022-07-23T22:38:08Z</dcterms:modified>
</cp:coreProperties>
</file>